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65" r:id="rId2"/>
    <p:sldId id="260" r:id="rId3"/>
    <p:sldId id="268" r:id="rId4"/>
    <p:sldId id="256" r:id="rId5"/>
    <p:sldId id="258" r:id="rId6"/>
    <p:sldId id="270" r:id="rId7"/>
    <p:sldId id="262" r:id="rId8"/>
    <p:sldId id="273" r:id="rId9"/>
    <p:sldId id="276" r:id="rId10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901"/>
    <a:srgbClr val="7D7DE9"/>
    <a:srgbClr val="EE9F00"/>
    <a:srgbClr val="FBCDD5"/>
    <a:srgbClr val="FFCCCC"/>
    <a:srgbClr val="FF99CC"/>
    <a:srgbClr val="FF7C80"/>
    <a:srgbClr val="FFC1C1"/>
    <a:srgbClr val="EC4675"/>
    <a:srgbClr val="F2227B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815" autoAdjust="0"/>
    <p:restoredTop sz="93977" autoAdjust="0"/>
  </p:normalViewPr>
  <p:slideViewPr>
    <p:cSldViewPr>
      <p:cViewPr>
        <p:scale>
          <a:sx n="100" d="100"/>
          <a:sy n="100" d="100"/>
        </p:scale>
        <p:origin x="-2112" y="-23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997586-29B1-4A86-B878-F472A376D021}" type="datetimeFigureOut">
              <a:rPr lang="en-US" smtClean="0"/>
              <a:pPr/>
              <a:t>11/15/2011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4FB3B1-26B2-43F7-BD6E-0A1DF8C367F6}" type="slidenum">
              <a:rPr lang="en-US" smtClean="0"/>
              <a:pPr/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9E87F-D5E3-419B-8D5F-4BB99DBB4BCE}" type="datetimeFigureOut">
              <a:rPr lang="en-US" smtClean="0"/>
              <a:pPr/>
              <a:t>11/15/201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412CF-FB46-463E-94D0-08455928525E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9E87F-D5E3-419B-8D5F-4BB99DBB4BCE}" type="datetimeFigureOut">
              <a:rPr lang="en-US" smtClean="0"/>
              <a:pPr/>
              <a:t>11/15/201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412CF-FB46-463E-94D0-08455928525E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9E87F-D5E3-419B-8D5F-4BB99DBB4BCE}" type="datetimeFigureOut">
              <a:rPr lang="en-US" smtClean="0"/>
              <a:pPr/>
              <a:t>11/15/201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412CF-FB46-463E-94D0-08455928525E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9E87F-D5E3-419B-8D5F-4BB99DBB4BCE}" type="datetimeFigureOut">
              <a:rPr lang="en-US" smtClean="0"/>
              <a:pPr/>
              <a:t>11/15/201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412CF-FB46-463E-94D0-08455928525E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9E87F-D5E3-419B-8D5F-4BB99DBB4BCE}" type="datetimeFigureOut">
              <a:rPr lang="en-US" smtClean="0"/>
              <a:pPr/>
              <a:t>11/15/201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412CF-FB46-463E-94D0-08455928525E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9E87F-D5E3-419B-8D5F-4BB99DBB4BCE}" type="datetimeFigureOut">
              <a:rPr lang="en-US" smtClean="0"/>
              <a:pPr/>
              <a:t>11/15/201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412CF-FB46-463E-94D0-08455928525E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9E87F-D5E3-419B-8D5F-4BB99DBB4BCE}" type="datetimeFigureOut">
              <a:rPr lang="en-US" smtClean="0"/>
              <a:pPr/>
              <a:t>11/15/2011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412CF-FB46-463E-94D0-08455928525E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9E87F-D5E3-419B-8D5F-4BB99DBB4BCE}" type="datetimeFigureOut">
              <a:rPr lang="en-US" smtClean="0"/>
              <a:pPr/>
              <a:t>11/15/2011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412CF-FB46-463E-94D0-08455928525E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9E87F-D5E3-419B-8D5F-4BB99DBB4BCE}" type="datetimeFigureOut">
              <a:rPr lang="en-US" smtClean="0"/>
              <a:pPr/>
              <a:t>11/15/2011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412CF-FB46-463E-94D0-08455928525E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9E87F-D5E3-419B-8D5F-4BB99DBB4BCE}" type="datetimeFigureOut">
              <a:rPr lang="en-US" smtClean="0"/>
              <a:pPr/>
              <a:t>11/15/201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412CF-FB46-463E-94D0-08455928525E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9E87F-D5E3-419B-8D5F-4BB99DBB4BCE}" type="datetimeFigureOut">
              <a:rPr lang="en-US" smtClean="0"/>
              <a:pPr/>
              <a:t>11/15/201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D412CF-FB46-463E-94D0-08455928525E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79E87F-D5E3-419B-8D5F-4BB99DBB4BCE}" type="datetimeFigureOut">
              <a:rPr lang="en-US" smtClean="0"/>
              <a:pPr/>
              <a:t>11/15/201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D412CF-FB46-463E-94D0-08455928525E}" type="slidenum">
              <a:rPr lang="en-US" smtClean="0"/>
              <a:pPr/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 descr="C_vs_E_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260648"/>
            <a:ext cx="9144000" cy="5573295"/>
          </a:xfrm>
          <a:prstGeom prst="rect">
            <a:avLst/>
          </a:prstGeom>
        </p:spPr>
      </p:pic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297508" y="5949280"/>
            <a:ext cx="8590813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</a:rPr>
              <a:t>Figure a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: Biochemical pathways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expressed in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U. minor  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treated with artificial scratching &amp; transferring eggs of the elm </a:t>
            </a:r>
          </a:p>
          <a:p>
            <a:pPr algn="just" fontAlgn="base">
              <a:spcBef>
                <a:spcPct val="0"/>
              </a:spcBef>
              <a:spcAft>
                <a:spcPct val="0"/>
              </a:spcAft>
            </a:pP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leaf beetle </a:t>
            </a:r>
            <a:r>
              <a:rPr lang="en-US" sz="1200" i="1" dirty="0" smtClean="0">
                <a:latin typeface="Arial" pitchFamily="34" charset="0"/>
                <a:ea typeface="Times New Roman" pitchFamily="18" charset="0"/>
              </a:rPr>
              <a:t>X. </a:t>
            </a:r>
            <a:r>
              <a:rPr lang="en-US" sz="1200" i="1" dirty="0" err="1" smtClean="0">
                <a:latin typeface="Arial" pitchFamily="34" charset="0"/>
                <a:ea typeface="Times New Roman" pitchFamily="18" charset="0"/>
              </a:rPr>
              <a:t>luteola</a:t>
            </a:r>
            <a:r>
              <a:rPr lang="en-US" sz="1200" i="1" dirty="0" smtClean="0">
                <a:latin typeface="Arial" pitchFamily="34" charset="0"/>
                <a:ea typeface="Times New Roman" pitchFamily="18" charset="0"/>
              </a:rPr>
              <a:t>  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(yellow)  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and  untreated control (green),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 expressed in both treatments (black).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Enzymes (EC numbers)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identified via blast searches against the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UniProt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database (E-value </a:t>
            </a:r>
            <a:r>
              <a:rPr kumimoji="0" lang="en-US" sz="1200" b="0" i="0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&lt;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1e-40) were used to generate the map with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iPath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. 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 descr="EF__vs_C_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260648"/>
            <a:ext cx="9144000" cy="5573295"/>
          </a:xfrm>
          <a:prstGeom prst="rect">
            <a:avLst/>
          </a:prstGeom>
        </p:spPr>
      </p:pic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108853" y="5949280"/>
            <a:ext cx="8552341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Figure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</a:rPr>
              <a:t>b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: Biochemical pathways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expressed in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U. minor  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treated with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oviposition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and feeding of the elm leaf beetle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X. </a:t>
            </a:r>
            <a:r>
              <a:rPr kumimoji="0" lang="en-US" sz="12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luteola</a:t>
            </a:r>
            <a:endParaRPr kumimoji="0" lang="de-DE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(blue)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and  untreated control (green),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 expressed in both treatments (black).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Enzymes (EC numbers)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identified via blast searches against the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UniProt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database (E-value </a:t>
            </a:r>
            <a:r>
              <a:rPr kumimoji="0" lang="en-US" sz="1200" b="0" i="0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&lt;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1e-40) were used to generate the map with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iPath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. 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467544" y="0"/>
            <a:ext cx="31569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F= </a:t>
            </a:r>
            <a:r>
              <a:rPr lang="en-US" dirty="0" err="1" smtClean="0"/>
              <a:t>blau</a:t>
            </a:r>
            <a:r>
              <a:rPr lang="en-US" dirty="0" smtClean="0"/>
              <a:t>, E=</a:t>
            </a:r>
            <a:r>
              <a:rPr lang="en-US" dirty="0" err="1" smtClean="0"/>
              <a:t>gelb</a:t>
            </a:r>
            <a:r>
              <a:rPr lang="en-US" dirty="0" smtClean="0"/>
              <a:t>, </a:t>
            </a:r>
            <a:r>
              <a:rPr lang="en-US" dirty="0" err="1" smtClean="0"/>
              <a:t>schwarz</a:t>
            </a:r>
            <a:r>
              <a:rPr lang="en-US" dirty="0" smtClean="0"/>
              <a:t> </a:t>
            </a:r>
            <a:r>
              <a:rPr lang="en-US" dirty="0" err="1" smtClean="0"/>
              <a:t>beide</a:t>
            </a:r>
            <a:endParaRPr lang="en-US" dirty="0"/>
          </a:p>
        </p:txBody>
      </p:sp>
      <p:pic>
        <p:nvPicPr>
          <p:cNvPr id="3" name="Grafik 2" descr="E_vs_EF_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332656"/>
            <a:ext cx="9144000" cy="5573295"/>
          </a:xfrm>
          <a:prstGeom prst="rect">
            <a:avLst/>
          </a:prstGeom>
        </p:spPr>
      </p:pic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0" y="5949280"/>
            <a:ext cx="9144000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</a:rPr>
              <a:t>Figure c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: Biochemical pathways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expressed in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U. minor  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treated with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oviposition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and feeding of the elm leaf beetle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X. </a:t>
            </a:r>
            <a:r>
              <a:rPr kumimoji="0" lang="en-US" sz="12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luteola</a:t>
            </a:r>
            <a:endParaRPr kumimoji="0" lang="de-DE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(blue)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and 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treated with artificial scratching &amp; transferring eggs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(yellow),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 expressed in both treatments (black).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Enzymes (EC numbers)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identified via blast searches against the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UniProt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database (E-value </a:t>
            </a:r>
            <a:r>
              <a:rPr kumimoji="0" lang="en-US" sz="1200" b="0" i="0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&lt;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1e-40) were used to generate the map with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iPath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. 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7" name="Grafik 6" descr="JA_vs_EF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188640"/>
            <a:ext cx="9144000" cy="5573295"/>
          </a:xfrm>
          <a:prstGeom prst="rect">
            <a:avLst/>
          </a:prstGeom>
        </p:spPr>
      </p:pic>
      <p:sp>
        <p:nvSpPr>
          <p:cNvPr id="33793" name="Rectangle 1"/>
          <p:cNvSpPr>
            <a:spLocks noChangeArrowheads="1"/>
          </p:cNvSpPr>
          <p:nvPr/>
        </p:nvSpPr>
        <p:spPr bwMode="auto">
          <a:xfrm>
            <a:off x="80673" y="5805264"/>
            <a:ext cx="8643713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Figure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</a:rPr>
              <a:t>d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: Biochemical pathways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expressed in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U. minor  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treated with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oviposition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and feeding of the elm leaf beetle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X. </a:t>
            </a:r>
            <a:r>
              <a:rPr kumimoji="0" lang="en-US" sz="12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luteola</a:t>
            </a:r>
            <a:endParaRPr kumimoji="0" lang="de-DE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(blue)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and 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treated with 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treatment with methyl </a:t>
            </a:r>
            <a:r>
              <a:rPr kumimoji="0" lang="en-US" sz="1200" b="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jamonate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 (cyan), expressed in both treatments (black).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Enzymes (EC numbers)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identified via blast searches against the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UniProt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database (E-value </a:t>
            </a:r>
            <a:r>
              <a:rPr kumimoji="0" lang="en-US" sz="1200" b="0" i="0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&lt;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1e-40) were used to generate the map with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iPath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. 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 descr="EF__vs_F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260648"/>
            <a:ext cx="9144000" cy="5573295"/>
          </a:xfrm>
          <a:prstGeom prst="rect">
            <a:avLst/>
          </a:prstGeom>
        </p:spPr>
      </p:pic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37821" y="5877272"/>
            <a:ext cx="9246442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Figure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</a:rPr>
              <a:t>e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Biochemical pathways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expressed in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U. minor 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treated with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oviposition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and feeding of the elm leaf beetle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X. </a:t>
            </a:r>
            <a:r>
              <a:rPr kumimoji="0" lang="en-US" sz="12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luteola</a:t>
            </a:r>
            <a:endParaRPr kumimoji="0" lang="de-DE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(blue)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and 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treated only with 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feeding (red),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 expressed in both treatments (black).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Enzymes (EC numbers)  identified via blast searches 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against the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UniProt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database (E-value </a:t>
            </a:r>
            <a:r>
              <a:rPr kumimoji="0" lang="en-US" sz="1200" b="0" i="0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&lt;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1e-40) were used to generate the map with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iPath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. 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 descr="F_vs_JA_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188640"/>
            <a:ext cx="9144000" cy="5573295"/>
          </a:xfrm>
          <a:prstGeom prst="rect">
            <a:avLst/>
          </a:prstGeom>
        </p:spPr>
      </p:pic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197018" y="5877272"/>
            <a:ext cx="8267007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Figure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</a:rPr>
              <a:t>f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: Biochemical pathways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expressed in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U. minor  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treated with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feeding of the elm leaf beetle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X. </a:t>
            </a:r>
            <a:r>
              <a:rPr kumimoji="0" lang="en-US" sz="12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luteola</a:t>
            </a:r>
            <a:endParaRPr kumimoji="0" lang="de-DE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(red)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and 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treated with </a:t>
            </a:r>
            <a:r>
              <a:rPr kumimoji="0" lang="en-US" sz="1200" b="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with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methyl </a:t>
            </a:r>
            <a:r>
              <a:rPr kumimoji="0" lang="en-US" sz="1200" b="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jamonate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 (cyan), expressed in both treatments (black).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Enzymes (EC numbers)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identified via blast searches against the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UniProt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database (E-value </a:t>
            </a:r>
            <a:r>
              <a:rPr kumimoji="0" lang="en-US" sz="1200" b="0" i="0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&lt;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1e-40) were used to generate the map with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iPath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. 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 descr="F_vs_C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188640"/>
            <a:ext cx="9144000" cy="5573295"/>
          </a:xfrm>
          <a:prstGeom prst="rect">
            <a:avLst/>
          </a:prstGeom>
        </p:spPr>
      </p:pic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251520" y="5877272"/>
            <a:ext cx="8267007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Figure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</a:rPr>
              <a:t>g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: Biochemical pathways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expressed in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U. minor  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treated with</a:t>
            </a:r>
            <a:r>
              <a:rPr lang="en-US" sz="1200" i="1" dirty="0" smtClean="0">
                <a:latin typeface="Arial" pitchFamily="34" charset="0"/>
                <a:ea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feeding of the elm leaf beetle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X. </a:t>
            </a:r>
            <a:r>
              <a:rPr kumimoji="0" lang="en-US" sz="12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luteola</a:t>
            </a:r>
            <a:endParaRPr kumimoji="0" lang="de-DE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(red)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and untreated control (green),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 expressed in both treatments (black).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Enzymes (EC numbers)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identified via blast searches against the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UniProt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database (E-value </a:t>
            </a:r>
            <a:r>
              <a:rPr kumimoji="0" lang="en-US" sz="1200" b="0" i="0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&lt;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1e-40) were used to generate the map with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iPath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. 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 descr="F_vs__EFF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260648"/>
            <a:ext cx="9144000" cy="5573295"/>
          </a:xfrm>
          <a:prstGeom prst="rect">
            <a:avLst/>
          </a:prstGeom>
        </p:spPr>
      </p:pic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229880" y="5877272"/>
            <a:ext cx="8310288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Figure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</a:rPr>
              <a:t>h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Biochemical pathways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expressed in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U. minor </a:t>
            </a:r>
            <a:r>
              <a:rPr lang="en-US" sz="1200" i="1" dirty="0" smtClean="0">
                <a:latin typeface="Arial" pitchFamily="34" charset="0"/>
                <a:ea typeface="Times New Roman" pitchFamily="18" charset="0"/>
              </a:rPr>
              <a:t> 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treated with </a:t>
            </a:r>
            <a:r>
              <a:rPr kumimoji="0" lang="en-US" sz="12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feeding of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the elm leaf beetle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X. </a:t>
            </a:r>
            <a:r>
              <a:rPr kumimoji="0" lang="en-US" sz="12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luteola</a:t>
            </a:r>
            <a:endParaRPr kumimoji="0" lang="de-DE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(blue)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and untreated control ,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 expressed in both treatments (black).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Enzymes (EC numbers)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identified via blast searches against the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UniProt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database (E-value </a:t>
            </a:r>
            <a:r>
              <a:rPr kumimoji="0" lang="en-US" sz="1200" b="0" i="0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&lt;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1e-40) were used to generate the map with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iPath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. 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 descr="C_vs__EFF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188640"/>
            <a:ext cx="9144000" cy="5573295"/>
          </a:xfrm>
          <a:prstGeom prst="rect">
            <a:avLst/>
          </a:prstGeom>
        </p:spPr>
      </p:pic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107504" y="5805264"/>
            <a:ext cx="8595623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Figure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</a:rPr>
              <a:t>i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: Biochemical pathways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expressed in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U. minor </a:t>
            </a:r>
            <a:r>
              <a:rPr lang="en-US" sz="1200" i="1" dirty="0" smtClean="0">
                <a:latin typeface="Arial" pitchFamily="34" charset="0"/>
                <a:ea typeface="Times New Roman" pitchFamily="18" charset="0"/>
              </a:rPr>
              <a:t> 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treated with </a:t>
            </a:r>
            <a:r>
              <a:rPr lang="en-US" sz="1200" dirty="0" err="1" smtClean="0">
                <a:latin typeface="Arial" pitchFamily="34" charset="0"/>
                <a:ea typeface="Times New Roman" pitchFamily="18" charset="0"/>
              </a:rPr>
              <a:t>oviposition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 and </a:t>
            </a:r>
            <a:r>
              <a:rPr kumimoji="0" lang="en-US" sz="12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feeding of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the elm leaf beetle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X. </a:t>
            </a:r>
            <a:r>
              <a:rPr kumimoji="0" lang="en-US" sz="12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luteola</a:t>
            </a:r>
            <a:endParaRPr kumimoji="0" lang="de-DE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(blue)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and untreated control,</a:t>
            </a:r>
            <a:r>
              <a:rPr lang="en-US" sz="1200" dirty="0" smtClean="0">
                <a:latin typeface="Arial" pitchFamily="34" charset="0"/>
                <a:ea typeface="Times New Roman" pitchFamily="18" charset="0"/>
              </a:rPr>
              <a:t> expressed in both treatments (black).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Enzymes (EC numbers)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identified via blast searches against the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UniProt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database (E-value </a:t>
            </a:r>
            <a:r>
              <a:rPr kumimoji="0" lang="en-US" sz="1200" b="0" i="0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&lt;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 1e-40) were used to generate the map with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iPath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</a:rPr>
              <a:t>. 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14</Words>
  <Application>Microsoft Office PowerPoint</Application>
  <PresentationFormat>Bildschirmpräsentation (4:3)</PresentationFormat>
  <Paragraphs>28</Paragraphs>
  <Slides>9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9</vt:i4>
      </vt:variant>
    </vt:vector>
  </HeadingPairs>
  <TitlesOfParts>
    <vt:vector size="10" baseType="lpstr">
      <vt:lpstr>Larissa-Design</vt:lpstr>
      <vt:lpstr>Folie 1</vt:lpstr>
      <vt:lpstr>Folie 2</vt:lpstr>
      <vt:lpstr>Folie 3</vt:lpstr>
      <vt:lpstr>Folie 4</vt:lpstr>
      <vt:lpstr>Folie 5</vt:lpstr>
      <vt:lpstr>Folie 6</vt:lpstr>
      <vt:lpstr>Folie 7</vt:lpstr>
      <vt:lpstr>Folie 8</vt:lpstr>
      <vt:lpstr>Folie 9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Studenten</dc:creator>
  <cp:lastModifiedBy>Studenten</cp:lastModifiedBy>
  <cp:revision>155</cp:revision>
  <dcterms:created xsi:type="dcterms:W3CDTF">2011-03-20T15:36:18Z</dcterms:created>
  <dcterms:modified xsi:type="dcterms:W3CDTF">2011-11-15T14:52:46Z</dcterms:modified>
</cp:coreProperties>
</file>